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2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66" autoAdjust="0"/>
    <p:restoredTop sz="83188" autoAdjust="0"/>
  </p:normalViewPr>
  <p:slideViewPr>
    <p:cSldViewPr snapToGrid="0">
      <p:cViewPr>
        <p:scale>
          <a:sx n="173" d="100"/>
          <a:sy n="173" d="100"/>
        </p:scale>
        <p:origin x="648" y="-4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64A5869B-E3F8-4D0C-B85B-89C0D610D772}" type="datetimeFigureOut">
              <a:rPr lang="en-US"/>
              <a:pPr>
                <a:defRPr/>
              </a:pPr>
              <a:t>9/10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4BC672E-142A-4EA5-9836-7064DCCA8B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89418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4. Library size and principal component analysi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Table showing library sizes of each sample. b. A principal component analysis (PCA) of the filtered data showing that 87% of the variance of the samples can be explained by differences in the stress states. See methods for more details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ol and heat correspond to normal and HS conditions, respectively. </a:t>
            </a:r>
            <a:endParaRPr lang="en-US">
              <a:effectLst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4BC672E-142A-4EA5-9836-7064DCCA8B23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D35F5F-5479-4B7C-A20C-2E25C7FA6FA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ECD154-1873-4F6A-8B4E-BCB875E386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C6A914-AAD6-4917-B5C4-29418955D56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1BF223-4448-4860-BCC0-5EDC78E1DF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8F3521-2F9D-4985-AE12-E625B469A8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43DCCA7-1E4E-49C2-8AD0-90D7D45F1D3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B09C9B-AEA4-49CE-9727-7F618BAACBE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E4024A-1AB8-40A8-92CF-DCB7BF82992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C7C9BA8-7D37-4214-9234-E9DD68C5218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87B1DF-9E15-4AC8-B5BE-8A2F8C92E7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0E680B-B9D9-43B5-99DC-97CAB0AB5A8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1"/>
            <a:ext cx="6172200" cy="60346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967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967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967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DAD13276-6E10-4652-821F-1519F9DC81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9547581"/>
              </p:ext>
            </p:extLst>
          </p:nvPr>
        </p:nvGraphicFramePr>
        <p:xfrm>
          <a:off x="621101" y="705069"/>
          <a:ext cx="2589347" cy="2867025"/>
        </p:xfrm>
        <a:graphic>
          <a:graphicData uri="http://schemas.openxmlformats.org/drawingml/2006/table">
            <a:tbl>
              <a:tblPr/>
              <a:tblGrid>
                <a:gridCol w="169002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9932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09550">
                <a:tc gridSpan="2"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sng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aw read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contro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(normal) Replicate1 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221307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contro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(normal) Replicate 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06904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contro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(normal) Replicate 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07935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hea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Replicate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14501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hea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Replicate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083985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WT_hea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Replicate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796836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_control (normal) Replicate 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239105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_control (normal) Replicate 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77907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_control (normal) Replicate 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30869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_heat Replicate 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19410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_heat Replicate 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60695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cngc16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_heat Replicate 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248864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550667" y="4155607"/>
            <a:ext cx="20217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b. Principal Component Analysis</a:t>
            </a:r>
            <a:endParaRPr lang="en-US" sz="1000" dirty="0"/>
          </a:p>
        </p:txBody>
      </p:sp>
      <p:grpSp>
        <p:nvGrpSpPr>
          <p:cNvPr id="68" name="Group 67"/>
          <p:cNvGrpSpPr/>
          <p:nvPr/>
        </p:nvGrpSpPr>
        <p:grpSpPr>
          <a:xfrm>
            <a:off x="56336" y="4455042"/>
            <a:ext cx="6566194" cy="3574952"/>
            <a:chOff x="55971" y="4169419"/>
            <a:chExt cx="6218218" cy="3784744"/>
          </a:xfrm>
        </p:grpSpPr>
        <p:sp>
          <p:nvSpPr>
            <p:cNvPr id="15" name="Rectangle 14"/>
            <p:cNvSpPr/>
            <p:nvPr/>
          </p:nvSpPr>
          <p:spPr>
            <a:xfrm>
              <a:off x="845377" y="4169419"/>
              <a:ext cx="5193473" cy="318028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757670" y="5405388"/>
              <a:ext cx="862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758372" y="5886877"/>
              <a:ext cx="862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752816" y="6342357"/>
              <a:ext cx="862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758574" y="6810146"/>
              <a:ext cx="862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5139024" y="7352387"/>
              <a:ext cx="0" cy="10351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4297922" y="7357952"/>
              <a:ext cx="0" cy="10351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422513" y="7344322"/>
              <a:ext cx="0" cy="10351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2552415" y="7344134"/>
              <a:ext cx="0" cy="10351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1686394" y="7343948"/>
              <a:ext cx="0" cy="10351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 rot="16200000">
              <a:off x="-814766" y="5149369"/>
              <a:ext cx="1974648" cy="233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Principal </a:t>
              </a:r>
              <a:r>
                <a:rPr lang="en-US" sz="1000" dirty="0"/>
                <a:t>2 = 8%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36520" y="7693493"/>
              <a:ext cx="1974648" cy="2606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Principle 1 </a:t>
              </a:r>
              <a:r>
                <a:rPr lang="en-US" sz="1000" dirty="0"/>
                <a:t>= 87%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68862" y="6679059"/>
              <a:ext cx="690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-2e+05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10181" y="5748827"/>
              <a:ext cx="690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e+05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0679" y="6198343"/>
              <a:ext cx="6901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e+0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524531" y="6850474"/>
              <a:ext cx="756249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00B050"/>
                  </a:solidFill>
                </a:rPr>
                <a:t>WT_control</a:t>
              </a:r>
              <a:r>
                <a:rPr lang="en-US" sz="800" dirty="0">
                  <a:solidFill>
                    <a:srgbClr val="00B050"/>
                  </a:solidFill>
                </a:rPr>
                <a:t>  Replicate 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404787" y="6598952"/>
              <a:ext cx="756249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00B050"/>
                  </a:solidFill>
                </a:rPr>
                <a:t>WT_control</a:t>
              </a:r>
              <a:r>
                <a:rPr lang="en-US" sz="800" dirty="0">
                  <a:solidFill>
                    <a:srgbClr val="00B050"/>
                  </a:solidFill>
                </a:rPr>
                <a:t>  Replicate 3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03923" y="7004320"/>
              <a:ext cx="756249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00B050"/>
                  </a:solidFill>
                </a:rPr>
                <a:t>WT_control</a:t>
              </a:r>
              <a:r>
                <a:rPr lang="en-US" sz="800" dirty="0">
                  <a:solidFill>
                    <a:srgbClr val="00B050"/>
                  </a:solidFill>
                </a:rPr>
                <a:t>  Replicate 2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425003" y="6094262"/>
              <a:ext cx="756250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FFC000"/>
                  </a:solidFill>
                </a:rPr>
                <a:t>WT_heat</a:t>
              </a:r>
              <a:r>
                <a:rPr lang="en-US" sz="800" dirty="0">
                  <a:solidFill>
                    <a:srgbClr val="FFC000"/>
                  </a:solidFill>
                </a:rPr>
                <a:t>  Replicate 2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877390" y="5733282"/>
              <a:ext cx="756250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FFC000"/>
                  </a:solidFill>
                </a:rPr>
                <a:t>WT_heat</a:t>
              </a:r>
              <a:r>
                <a:rPr lang="en-US" sz="800" dirty="0">
                  <a:solidFill>
                    <a:srgbClr val="FFC000"/>
                  </a:solidFill>
                </a:rPr>
                <a:t>  Replicate 1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363805" y="5988500"/>
              <a:ext cx="756250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solidFill>
                    <a:srgbClr val="FFC000"/>
                  </a:solidFill>
                </a:rPr>
                <a:t>WT_heat</a:t>
              </a:r>
              <a:r>
                <a:rPr lang="en-US" sz="800" dirty="0">
                  <a:solidFill>
                    <a:srgbClr val="FFC000"/>
                  </a:solidFill>
                </a:rPr>
                <a:t>  Replicate 3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109807" y="6160693"/>
              <a:ext cx="914377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0070C0"/>
                  </a:solidFill>
                </a:rPr>
                <a:t>cngc16</a:t>
              </a:r>
              <a:r>
                <a:rPr lang="en-US" sz="800" dirty="0">
                  <a:solidFill>
                    <a:srgbClr val="0070C0"/>
                  </a:solidFill>
                </a:rPr>
                <a:t>_control  Replicate 2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638453" y="6363684"/>
              <a:ext cx="914377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0070C0"/>
                  </a:solidFill>
                </a:rPr>
                <a:t>cngc16</a:t>
              </a:r>
              <a:r>
                <a:rPr lang="en-US" sz="800" dirty="0">
                  <a:solidFill>
                    <a:srgbClr val="0070C0"/>
                  </a:solidFill>
                </a:rPr>
                <a:t>_control  Replicate 1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15651" y="4170625"/>
              <a:ext cx="914377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0070C0"/>
                  </a:solidFill>
                </a:rPr>
                <a:t>cngc16</a:t>
              </a:r>
              <a:r>
                <a:rPr lang="en-US" sz="800" dirty="0">
                  <a:solidFill>
                    <a:srgbClr val="0070C0"/>
                  </a:solidFill>
                </a:rPr>
                <a:t>_control Replicate 3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359810" y="5682666"/>
              <a:ext cx="914379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FF0000"/>
                  </a:solidFill>
                </a:rPr>
                <a:t>cngc16</a:t>
              </a:r>
              <a:r>
                <a:rPr lang="en-US" sz="800" dirty="0">
                  <a:solidFill>
                    <a:srgbClr val="FF0000"/>
                  </a:solidFill>
                </a:rPr>
                <a:t>_heat Replicate 2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485691" y="5506553"/>
              <a:ext cx="914379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FF0000"/>
                  </a:solidFill>
                </a:rPr>
                <a:t>cngc16</a:t>
              </a:r>
              <a:r>
                <a:rPr lang="en-US" sz="800" dirty="0">
                  <a:solidFill>
                    <a:srgbClr val="FF0000"/>
                  </a:solidFill>
                </a:rPr>
                <a:t>_heat Replicate 3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945546" y="5972232"/>
              <a:ext cx="914377" cy="358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i="1" dirty="0">
                  <a:solidFill>
                    <a:srgbClr val="FF0000"/>
                  </a:solidFill>
                </a:rPr>
                <a:t>cngc16</a:t>
              </a:r>
              <a:r>
                <a:rPr lang="en-US" sz="800" dirty="0">
                  <a:solidFill>
                    <a:srgbClr val="FF0000"/>
                  </a:solidFill>
                </a:rPr>
                <a:t>_heat Replicate 1</a:t>
              </a:r>
            </a:p>
          </p:txBody>
        </p:sp>
      </p:grpSp>
      <p:sp>
        <p:nvSpPr>
          <p:cNvPr id="67" name="Rectangle 66"/>
          <p:cNvSpPr/>
          <p:nvPr/>
        </p:nvSpPr>
        <p:spPr>
          <a:xfrm>
            <a:off x="580246" y="669212"/>
            <a:ext cx="10438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a. Library sizes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310334" y="5475383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e+05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472378" y="7535957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-1e+06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382657" y="7530020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-5e+05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3347777" y="7524082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0e+00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274042" y="7530019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e+05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165620" y="7524081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e+06</a:t>
            </a:r>
          </a:p>
        </p:txBody>
      </p:sp>
      <p:cxnSp>
        <p:nvCxnSpPr>
          <p:cNvPr id="44" name="Straight Connector 43"/>
          <p:cNvCxnSpPr/>
          <p:nvPr/>
        </p:nvCxnSpPr>
        <p:spPr>
          <a:xfrm>
            <a:off x="792544" y="5090743"/>
            <a:ext cx="862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97638" y="4973580"/>
            <a:ext cx="690113" cy="246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e+05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12</TotalTime>
  <Words>207</Words>
  <Application>Microsoft Macintosh PowerPoint</Application>
  <PresentationFormat>On-screen Show (4:3)</PresentationFormat>
  <Paragraphs>5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Default Design</vt:lpstr>
      <vt:lpstr>PowerPoint Presentation</vt:lpstr>
    </vt:vector>
  </TitlesOfParts>
  <LinksUpToDate>false</LinksUpToDate>
  <SharedDoc>false</SharedDoc>
  <HyperlinksChanged>false</HyperlinksChanged>
  <AppVersion>15.003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zdemir</dc:creator>
  <cp:lastModifiedBy>Jeffrey Harper</cp:lastModifiedBy>
  <cp:revision>1003</cp:revision>
  <cp:lastPrinted>2011-12-24T17:49:18Z</cp:lastPrinted>
  <dcterms:created xsi:type="dcterms:W3CDTF">2012-09-24T19:27:10Z</dcterms:created>
  <dcterms:modified xsi:type="dcterms:W3CDTF">2017-09-10T21:43:32Z</dcterms:modified>
</cp:coreProperties>
</file>